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  <p:sldId id="267" r:id="rId3"/>
  </p:sldIdLst>
  <p:sldSz cx="6858000" cy="9906000" type="A4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2" autoAdjust="0"/>
    <p:restoredTop sz="94660"/>
  </p:normalViewPr>
  <p:slideViewPr>
    <p:cSldViewPr snapToGrid="0">
      <p:cViewPr>
        <p:scale>
          <a:sx n="100" d="100"/>
          <a:sy n="100" d="100"/>
        </p:scale>
        <p:origin x="1194" y="-14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6D0D7-D0DF-4FAB-86B7-0EFA01B7D165}" type="datetimeFigureOut">
              <a:rPr kumimoji="1" lang="ja-JP" altLang="en-US" smtClean="0"/>
              <a:t>2021/1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A0A98-9B98-452A-B6B2-3283A07B2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5110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6D0D7-D0DF-4FAB-86B7-0EFA01B7D165}" type="datetimeFigureOut">
              <a:rPr kumimoji="1" lang="ja-JP" altLang="en-US" smtClean="0"/>
              <a:t>2021/1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A0A98-9B98-452A-B6B2-3283A07B2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66271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6D0D7-D0DF-4FAB-86B7-0EFA01B7D165}" type="datetimeFigureOut">
              <a:rPr kumimoji="1" lang="ja-JP" altLang="en-US" smtClean="0"/>
              <a:t>2021/1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A0A98-9B98-452A-B6B2-3283A07B2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1795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6D0D7-D0DF-4FAB-86B7-0EFA01B7D165}" type="datetimeFigureOut">
              <a:rPr kumimoji="1" lang="ja-JP" altLang="en-US" smtClean="0"/>
              <a:t>2021/1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A0A98-9B98-452A-B6B2-3283A07B2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6028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6D0D7-D0DF-4FAB-86B7-0EFA01B7D165}" type="datetimeFigureOut">
              <a:rPr kumimoji="1" lang="ja-JP" altLang="en-US" smtClean="0"/>
              <a:t>2021/1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A0A98-9B98-452A-B6B2-3283A07B2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88823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6D0D7-D0DF-4FAB-86B7-0EFA01B7D165}" type="datetimeFigureOut">
              <a:rPr kumimoji="1" lang="ja-JP" altLang="en-US" smtClean="0"/>
              <a:t>2021/12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A0A98-9B98-452A-B6B2-3283A07B2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53819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6D0D7-D0DF-4FAB-86B7-0EFA01B7D165}" type="datetimeFigureOut">
              <a:rPr kumimoji="1" lang="ja-JP" altLang="en-US" smtClean="0"/>
              <a:t>2021/12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A0A98-9B98-452A-B6B2-3283A07B2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1881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6D0D7-D0DF-4FAB-86B7-0EFA01B7D165}" type="datetimeFigureOut">
              <a:rPr kumimoji="1" lang="ja-JP" altLang="en-US" smtClean="0"/>
              <a:t>2021/12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A0A98-9B98-452A-B6B2-3283A07B2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80268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6D0D7-D0DF-4FAB-86B7-0EFA01B7D165}" type="datetimeFigureOut">
              <a:rPr kumimoji="1" lang="ja-JP" altLang="en-US" smtClean="0"/>
              <a:t>2021/12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A0A98-9B98-452A-B6B2-3283A07B2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24630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6D0D7-D0DF-4FAB-86B7-0EFA01B7D165}" type="datetimeFigureOut">
              <a:rPr kumimoji="1" lang="ja-JP" altLang="en-US" smtClean="0"/>
              <a:t>2021/12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A0A98-9B98-452A-B6B2-3283A07B2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29364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6D0D7-D0DF-4FAB-86B7-0EFA01B7D165}" type="datetimeFigureOut">
              <a:rPr kumimoji="1" lang="ja-JP" altLang="en-US" smtClean="0"/>
              <a:t>2021/12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A0A98-9B98-452A-B6B2-3283A07B2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40314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66D0D7-D0DF-4FAB-86B7-0EFA01B7D165}" type="datetimeFigureOut">
              <a:rPr kumimoji="1" lang="ja-JP" altLang="en-US" smtClean="0"/>
              <a:t>2021/1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BA0A98-9B98-452A-B6B2-3283A07B28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1857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38644D8-785A-4351-97E7-EFEBBCDC67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BAE43A4-02D8-4D4B-96C5-E1BC079E6B3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pic>
        <p:nvPicPr>
          <p:cNvPr id="4" name="Picture 2">
            <a:extLst>
              <a:ext uri="{FF2B5EF4-FFF2-40B4-BE49-F238E27FC236}">
                <a16:creationId xmlns:a16="http://schemas.microsoft.com/office/drawing/2014/main" id="{F6D43365-2873-47C3-9945-968CAD4EA8B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76672" y="1496616"/>
            <a:ext cx="5472608" cy="14080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3">
            <a:extLst>
              <a:ext uri="{FF2B5EF4-FFF2-40B4-BE49-F238E27FC236}">
                <a16:creationId xmlns:a16="http://schemas.microsoft.com/office/drawing/2014/main" id="{38C0A44B-B50B-4D41-8B82-8104DE4B0D4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76672" y="3024231"/>
            <a:ext cx="5472608" cy="14080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A41B709-0C3E-415E-BDBB-45FFAE8CEDE3}"/>
              </a:ext>
            </a:extLst>
          </p:cNvPr>
          <p:cNvSpPr txBox="1"/>
          <p:nvPr/>
        </p:nvSpPr>
        <p:spPr>
          <a:xfrm>
            <a:off x="608044" y="4951228"/>
            <a:ext cx="56419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1. GCMS spectra of peak 1 (A) and peak 2 (B) in Fig. 1. Peak 1 and 2 were identified as isoprene and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-MBO respectively based on comparison of retention time  with authentic standard and MS spectra with NIST library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B54D50E-1030-4386-869A-F483DA919A38}"/>
              </a:ext>
            </a:extLst>
          </p:cNvPr>
          <p:cNvSpPr txBox="1"/>
          <p:nvPr/>
        </p:nvSpPr>
        <p:spPr>
          <a:xfrm>
            <a:off x="839972" y="161614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2740AAE-9E8C-4E44-B758-9BBD1CE8F803}"/>
              </a:ext>
            </a:extLst>
          </p:cNvPr>
          <p:cNvSpPr txBox="1"/>
          <p:nvPr/>
        </p:nvSpPr>
        <p:spPr>
          <a:xfrm>
            <a:off x="847988" y="317964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B4C5414-C6F8-40DD-ABA8-64E48B0DEB33}"/>
              </a:ext>
            </a:extLst>
          </p:cNvPr>
          <p:cNvSpPr txBox="1"/>
          <p:nvPr/>
        </p:nvSpPr>
        <p:spPr>
          <a:xfrm>
            <a:off x="2900375" y="4551846"/>
            <a:ext cx="4908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M/Z</a:t>
            </a:r>
            <a:endParaRPr kumimoji="1" lang="ja-JP" altLang="en-US" sz="14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51CC492-B532-4522-B372-EC8A39916434}"/>
              </a:ext>
            </a:extLst>
          </p:cNvPr>
          <p:cNvSpPr txBox="1"/>
          <p:nvPr/>
        </p:nvSpPr>
        <p:spPr>
          <a:xfrm>
            <a:off x="4484097" y="9335387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ry Fig. S1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5431728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194C3E81-F8E6-4ED4-92D2-348D7601B3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1962" y="2541857"/>
            <a:ext cx="5934075" cy="5410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97782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3</TotalTime>
  <Words>60</Words>
  <Application>Microsoft Office PowerPoint</Application>
  <PresentationFormat>A4 210 x 297 mm</PresentationFormat>
  <Paragraphs>5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屋 宏典</dc:creator>
  <cp:lastModifiedBy>屋 宏典</cp:lastModifiedBy>
  <cp:revision>46</cp:revision>
  <cp:lastPrinted>2021-05-19T01:36:17Z</cp:lastPrinted>
  <dcterms:created xsi:type="dcterms:W3CDTF">2021-05-15T11:43:02Z</dcterms:created>
  <dcterms:modified xsi:type="dcterms:W3CDTF">2021-12-08T01:24:46Z</dcterms:modified>
</cp:coreProperties>
</file>